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56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108" y="10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7/06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7/06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7/06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7/06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7/06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7/06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7/06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7/06/2022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7/06/2022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7/06/2022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7/06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7/06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7/06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23528" y="5842337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 err="1"/>
              <a:t>Kremers</a:t>
            </a:r>
            <a:r>
              <a:rPr lang="en-GB" dirty="0"/>
              <a:t> et al (2022) Diabetologia DOI 10.1007/s00125-022-05738-x </a:t>
            </a:r>
          </a:p>
          <a:p>
            <a:r>
              <a:rPr lang="en-GB" sz="1200" dirty="0"/>
              <a:t>©The Authors 2022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Association between mental disorders and incidence of type 2 diabetes (precision prevention)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E98014C0-2B5C-4539-9370-8E8B5D2EC4D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42288" y="981270"/>
            <a:ext cx="4633968" cy="51120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6E070DB1-5DF1-4859-9A0B-4543804E5928}"/>
              </a:ext>
            </a:extLst>
          </p:cNvPr>
          <p:cNvSpPr txBox="1"/>
          <p:nvPr/>
        </p:nvSpPr>
        <p:spPr>
          <a:xfrm>
            <a:off x="323528" y="260648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Effect of treatment for mental disorders on glycaemic variables in diabetes (precision treatment)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B3978962-7DD9-465F-AEB5-6A4E28F1F25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03648" y="1069767"/>
            <a:ext cx="6066756" cy="491118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1AF31A8-BBD0-25DF-32C8-A67F6FAE665D}"/>
              </a:ext>
            </a:extLst>
          </p:cNvPr>
          <p:cNvSpPr txBox="1"/>
          <p:nvPr/>
        </p:nvSpPr>
        <p:spPr>
          <a:xfrm>
            <a:off x="323528" y="5842337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 err="1"/>
              <a:t>Kremers</a:t>
            </a:r>
            <a:r>
              <a:rPr lang="en-GB" dirty="0"/>
              <a:t> et al (2022) Diabetologia DOI 10.1007/s00125-022-05738-x </a:t>
            </a:r>
          </a:p>
          <a:p>
            <a:r>
              <a:rPr lang="en-GB" sz="1200" dirty="0"/>
              <a:t>©The Authors 2022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10</Words>
  <Application>Microsoft Office PowerPoint</Application>
  <PresentationFormat>On-screen Show (4:3)</PresentationFormat>
  <Paragraphs>9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Madeleine Stimpson</cp:lastModifiedBy>
  <cp:revision>42</cp:revision>
  <dcterms:created xsi:type="dcterms:W3CDTF">2016-06-15T12:53:43Z</dcterms:created>
  <dcterms:modified xsi:type="dcterms:W3CDTF">2022-06-17T14:12:51Z</dcterms:modified>
</cp:coreProperties>
</file>